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516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D83F"/>
    <a:srgbClr val="9CEA45"/>
    <a:srgbClr val="5B994B"/>
    <a:srgbClr val="A2CE37"/>
    <a:srgbClr val="7CB84B"/>
    <a:srgbClr val="A455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25" autoAdjust="0"/>
    <p:restoredTop sz="50000" autoAdjust="0"/>
  </p:normalViewPr>
  <p:slideViewPr>
    <p:cSldViewPr snapToGrid="0" snapToObjects="1" showGuides="1">
      <p:cViewPr>
        <p:scale>
          <a:sx n="130" d="100"/>
          <a:sy n="130" d="100"/>
        </p:scale>
        <p:origin x="1048" y="-216"/>
      </p:cViewPr>
      <p:guideLst>
        <p:guide orient="horz" pos="3657"/>
        <p:guide pos="51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2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3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5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3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30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09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68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0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98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674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1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922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962989"/>
              </p:ext>
            </p:extLst>
          </p:nvPr>
        </p:nvGraphicFramePr>
        <p:xfrm>
          <a:off x="1548130" y="3633357"/>
          <a:ext cx="5864860" cy="10972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66215"/>
                <a:gridCol w="1466215"/>
                <a:gridCol w="1466215"/>
                <a:gridCol w="1466215"/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ample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riginal spin column 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vernight 25mg spin column 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uregene 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2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97</a:t>
                      </a:r>
                      <a:endParaRPr lang="en-US" sz="12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05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03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4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01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98</a:t>
                      </a:r>
                      <a:endParaRPr lang="en-US" sz="12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9</a:t>
                      </a:r>
                      <a:endParaRPr lang="en-US" sz="12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1035431" y="5020416"/>
            <a:ext cx="707313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dirty="0">
                <a:latin typeface="Calibri" charset="0"/>
                <a:ea typeface="ＭＳ 明朝" charset="-128"/>
                <a:cs typeface="Segoe UI" charset="0"/>
              </a:rPr>
              <a:t>Table </a:t>
            </a:r>
            <a:r>
              <a:rPr lang="en-US" sz="1200" b="1" dirty="0" smtClean="0">
                <a:latin typeface="Calibri" charset="0"/>
                <a:ea typeface="ＭＳ 明朝" charset="-128"/>
                <a:cs typeface="Segoe UI" charset="0"/>
              </a:rPr>
              <a:t>S6. </a:t>
            </a:r>
            <a:r>
              <a:rPr lang="en-US" sz="1200" b="1" i="1" dirty="0">
                <a:latin typeface="Calibri" charset="0"/>
                <a:ea typeface="ＭＳ 明朝" charset="-128"/>
                <a:cs typeface="Segoe UI" charset="0"/>
              </a:rPr>
              <a:t>SNCA</a:t>
            </a:r>
            <a:r>
              <a:rPr lang="en-US" sz="1200" b="1" dirty="0">
                <a:latin typeface="Calibri" charset="0"/>
                <a:ea typeface="ＭＳ 明朝" charset="-128"/>
                <a:cs typeface="Segoe UI" charset="0"/>
              </a:rPr>
              <a:t> CN by ddPCR in two control cerebellar samples, using DNA extracted with different protocols.</a:t>
            </a:r>
            <a:endParaRPr lang="en-US" sz="1200" dirty="0">
              <a:effectLst/>
              <a:latin typeface="Segoe UI" charset="0"/>
              <a:ea typeface="ＭＳ 明朝" charset="-128"/>
              <a:cs typeface="Segoe U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0431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6</TotalTime>
  <Words>37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Calibri</vt:lpstr>
      <vt:lpstr>Cambria</vt:lpstr>
      <vt:lpstr>ＭＳ 明朝</vt:lpstr>
      <vt:lpstr>Segoe UI</vt:lpstr>
      <vt:lpstr>Times New Roman</vt:lpstr>
      <vt:lpstr>Arial</vt:lpstr>
      <vt:lpstr>Office Theme</vt:lpstr>
      <vt:lpstr>PowerPoint Presentation</vt:lpstr>
    </vt:vector>
  </TitlesOfParts>
  <Company>UCLMS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Proukakis</dc:creator>
  <cp:lastModifiedBy>Christos Proukakis</cp:lastModifiedBy>
  <cp:revision>566</cp:revision>
  <dcterms:created xsi:type="dcterms:W3CDTF">2015-06-01T09:06:36Z</dcterms:created>
  <dcterms:modified xsi:type="dcterms:W3CDTF">2017-06-21T19:53:09Z</dcterms:modified>
</cp:coreProperties>
</file>